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82" d="100"/>
          <a:sy n="82" d="100"/>
        </p:scale>
        <p:origin x="125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1A6C6-C049-409A-B72F-67BB84B4C8D5}" type="datetimeFigureOut">
              <a:rPr lang="en-US" smtClean="0"/>
              <a:t>1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1FBE2-588F-4FF7-92F5-3FE6F712D5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1482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1A6C6-C049-409A-B72F-67BB84B4C8D5}" type="datetimeFigureOut">
              <a:rPr lang="en-US" smtClean="0"/>
              <a:t>1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1FBE2-588F-4FF7-92F5-3FE6F712D5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64658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1A6C6-C049-409A-B72F-67BB84B4C8D5}" type="datetimeFigureOut">
              <a:rPr lang="en-US" smtClean="0"/>
              <a:t>1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1FBE2-588F-4FF7-92F5-3FE6F712D5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47490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1A6C6-C049-409A-B72F-67BB84B4C8D5}" type="datetimeFigureOut">
              <a:rPr lang="en-US" smtClean="0"/>
              <a:t>1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1FBE2-588F-4FF7-92F5-3FE6F712D5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33438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1A6C6-C049-409A-B72F-67BB84B4C8D5}" type="datetimeFigureOut">
              <a:rPr lang="en-US" smtClean="0"/>
              <a:t>1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1FBE2-588F-4FF7-92F5-3FE6F712D5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62155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1A6C6-C049-409A-B72F-67BB84B4C8D5}" type="datetimeFigureOut">
              <a:rPr lang="en-US" smtClean="0"/>
              <a:t>1/1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1FBE2-588F-4FF7-92F5-3FE6F712D5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2052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1A6C6-C049-409A-B72F-67BB84B4C8D5}" type="datetimeFigureOut">
              <a:rPr lang="en-US" smtClean="0"/>
              <a:t>1/1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1FBE2-588F-4FF7-92F5-3FE6F712D5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02498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1A6C6-C049-409A-B72F-67BB84B4C8D5}" type="datetimeFigureOut">
              <a:rPr lang="en-US" smtClean="0"/>
              <a:t>1/1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1FBE2-588F-4FF7-92F5-3FE6F712D5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28842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1A6C6-C049-409A-B72F-67BB84B4C8D5}" type="datetimeFigureOut">
              <a:rPr lang="en-US" smtClean="0"/>
              <a:t>1/1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1FBE2-588F-4FF7-92F5-3FE6F712D5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2352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1A6C6-C049-409A-B72F-67BB84B4C8D5}" type="datetimeFigureOut">
              <a:rPr lang="en-US" smtClean="0"/>
              <a:t>1/1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1FBE2-588F-4FF7-92F5-3FE6F712D5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6957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1A6C6-C049-409A-B72F-67BB84B4C8D5}" type="datetimeFigureOut">
              <a:rPr lang="en-US" smtClean="0"/>
              <a:t>1/1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1FBE2-588F-4FF7-92F5-3FE6F712D5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28690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B1A6C6-C049-409A-B72F-67BB84B4C8D5}" type="datetimeFigureOut">
              <a:rPr lang="en-US" smtClean="0"/>
              <a:t>1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F1FBE2-588F-4FF7-92F5-3FE6F712D5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49614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2851816" y="2236083"/>
            <a:ext cx="4091909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68580" tIns="34290" rIns="68580" bIns="3429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sz="1350"/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87840665"/>
              </p:ext>
            </p:extLst>
          </p:nvPr>
        </p:nvGraphicFramePr>
        <p:xfrm>
          <a:off x="780585" y="1213566"/>
          <a:ext cx="5512537" cy="552020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" name="Image" r:id="rId3" imgW="6851257" imgH="6862644" progId="Photoshop.Image.13">
                  <p:embed/>
                </p:oleObj>
              </mc:Choice>
              <mc:Fallback>
                <p:oleObj name="Image" r:id="rId3" imgW="6851257" imgH="6862644" progId="Photoshop.Image.13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80585" y="1213566"/>
                        <a:ext cx="5512537" cy="5520203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ectangle 5"/>
          <p:cNvSpPr/>
          <p:nvPr/>
        </p:nvSpPr>
        <p:spPr>
          <a:xfrm>
            <a:off x="646664" y="7075784"/>
            <a:ext cx="5646458" cy="5170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750"/>
              </a:spcAft>
            </a:pP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</a:rPr>
              <a:t>S1 Fig.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Scanning 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</a:rPr>
              <a:t>electron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microscope image of 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</a:rPr>
              <a:t>CellSieve</a:t>
            </a:r>
            <a:r>
              <a:rPr lang="en-US" sz="1200" baseline="30000" dirty="0" err="1">
                <a:latin typeface="Arial" panose="020B0604020202020204" pitchFamily="34" charset="0"/>
                <a:ea typeface="Times New Roman" panose="02020603050405020304" pitchFamily="18" charset="0"/>
              </a:rPr>
              <a:t>TM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</a:rPr>
              <a:t>microfilters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with 7-µm diameter pores in a uniform array</a:t>
            </a:r>
            <a:endParaRPr lang="en-US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54161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18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Image</vt:lpstr>
      <vt:lpstr>PowerPoint Presentation</vt:lpstr>
    </vt:vector>
  </TitlesOfParts>
  <Company>IT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reeraj, Gopinathan Pillai</dc:creator>
  <cp:lastModifiedBy>Sreeraj, Gopinathan Pillai</cp:lastModifiedBy>
  <cp:revision>3</cp:revision>
  <dcterms:created xsi:type="dcterms:W3CDTF">2016-08-01T16:41:17Z</dcterms:created>
  <dcterms:modified xsi:type="dcterms:W3CDTF">2017-01-18T21:10:42Z</dcterms:modified>
</cp:coreProperties>
</file>